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98" r:id="rId2"/>
    <p:sldId id="299" r:id="rId3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30"/>
    <p:restoredTop sz="94659"/>
  </p:normalViewPr>
  <p:slideViewPr>
    <p:cSldViewPr snapToGrid="0" snapToObjects="1">
      <p:cViewPr>
        <p:scale>
          <a:sx n="100" d="100"/>
          <a:sy n="100" d="100"/>
        </p:scale>
        <p:origin x="123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DA438-138C-1D40-985E-1FA3BD32FBA0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88FC08-B105-1D4D-A239-200D83ACF4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62106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DA438-138C-1D40-985E-1FA3BD32FBA0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88FC08-B105-1D4D-A239-200D83ACF4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93873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DA438-138C-1D40-985E-1FA3BD32FBA0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88FC08-B105-1D4D-A239-200D83ACF4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2649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DA438-138C-1D40-985E-1FA3BD32FBA0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88FC08-B105-1D4D-A239-200D83ACF4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58106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DA438-138C-1D40-985E-1FA3BD32FBA0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88FC08-B105-1D4D-A239-200D83ACF4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40331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DA438-138C-1D40-985E-1FA3BD32FBA0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88FC08-B105-1D4D-A239-200D83ACF4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68815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DA438-138C-1D40-985E-1FA3BD32FBA0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88FC08-B105-1D4D-A239-200D83ACF4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14044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DA438-138C-1D40-985E-1FA3BD32FBA0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88FC08-B105-1D4D-A239-200D83ACF4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32021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DA438-138C-1D40-985E-1FA3BD32FBA0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88FC08-B105-1D4D-A239-200D83ACF4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97411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DA438-138C-1D40-985E-1FA3BD32FBA0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88FC08-B105-1D4D-A239-200D83ACF4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41066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DA438-138C-1D40-985E-1FA3BD32FBA0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88FC08-B105-1D4D-A239-200D83ACF4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46348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2DA438-138C-1D40-985E-1FA3BD32FBA0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88FC08-B105-1D4D-A239-200D83ACF4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22722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CF1B1361-79F1-4922-B0AC-B2D94D9AD41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64483898"/>
              </p:ext>
            </p:extLst>
          </p:nvPr>
        </p:nvGraphicFramePr>
        <p:xfrm>
          <a:off x="1160457" y="279846"/>
          <a:ext cx="4537086" cy="9520507"/>
        </p:xfrm>
        <a:graphic>
          <a:graphicData uri="http://schemas.openxmlformats.org/drawingml/2006/table">
            <a:tbl>
              <a:tblPr/>
              <a:tblGrid>
                <a:gridCol w="500702">
                  <a:extLst>
                    <a:ext uri="{9D8B030D-6E8A-4147-A177-3AD203B41FA5}">
                      <a16:colId xmlns:a16="http://schemas.microsoft.com/office/drawing/2014/main" val="3389532477"/>
                    </a:ext>
                  </a:extLst>
                </a:gridCol>
                <a:gridCol w="836230">
                  <a:extLst>
                    <a:ext uri="{9D8B030D-6E8A-4147-A177-3AD203B41FA5}">
                      <a16:colId xmlns:a16="http://schemas.microsoft.com/office/drawing/2014/main" val="1267317755"/>
                    </a:ext>
                  </a:extLst>
                </a:gridCol>
                <a:gridCol w="33784">
                  <a:extLst>
                    <a:ext uri="{9D8B030D-6E8A-4147-A177-3AD203B41FA5}">
                      <a16:colId xmlns:a16="http://schemas.microsoft.com/office/drawing/2014/main" val="2794840370"/>
                    </a:ext>
                  </a:extLst>
                </a:gridCol>
                <a:gridCol w="1093353">
                  <a:extLst>
                    <a:ext uri="{9D8B030D-6E8A-4147-A177-3AD203B41FA5}">
                      <a16:colId xmlns:a16="http://schemas.microsoft.com/office/drawing/2014/main" val="4032023729"/>
                    </a:ext>
                  </a:extLst>
                </a:gridCol>
                <a:gridCol w="1269021">
                  <a:extLst>
                    <a:ext uri="{9D8B030D-6E8A-4147-A177-3AD203B41FA5}">
                      <a16:colId xmlns:a16="http://schemas.microsoft.com/office/drawing/2014/main" val="95904098"/>
                    </a:ext>
                  </a:extLst>
                </a:gridCol>
                <a:gridCol w="803996">
                  <a:extLst>
                    <a:ext uri="{9D8B030D-6E8A-4147-A177-3AD203B41FA5}">
                      <a16:colId xmlns:a16="http://schemas.microsoft.com/office/drawing/2014/main" val="3286835321"/>
                    </a:ext>
                  </a:extLst>
                </a:gridCol>
              </a:tblGrid>
              <a:tr h="174200">
                <a:tc gridSpan="6">
                  <a:txBody>
                    <a:bodyPr/>
                    <a:lstStyle/>
                    <a:p>
                      <a:pPr algn="l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upplementary Table S1. Primer sets used in this study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t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67555936"/>
                  </a:ext>
                </a:extLst>
              </a:tr>
              <a:tr h="174200"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Target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t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</a:rPr>
                        <a:t>　</a:t>
                      </a:r>
                    </a:p>
                  </a:txBody>
                  <a:tcPr marL="2701" marR="2701" marT="2701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mplicon (bp)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9727888"/>
                  </a:ext>
                </a:extLst>
              </a:tr>
              <a:tr h="145589">
                <a:tc gridSpan="6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Primer sets for molecular cloning (5′ to 3′)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2135767"/>
                  </a:ext>
                </a:extLst>
              </a:tr>
              <a:tr h="145589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slc1a6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CTACATCGGGAGGGAAAGATTG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590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30177495"/>
                  </a:ext>
                </a:extLst>
              </a:tr>
              <a:tr h="1455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GGATTCTTGCGGGTGACTATAA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55609948"/>
                  </a:ext>
                </a:extLst>
              </a:tr>
              <a:tr h="145589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slc3a1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CAAGTGGGCCTACACGATATT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631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15315961"/>
                  </a:ext>
                </a:extLst>
              </a:tr>
              <a:tr h="1455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GTTCACGGTACAGGGTCAAA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67777455"/>
                  </a:ext>
                </a:extLst>
              </a:tr>
              <a:tr h="145589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slc3a2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GCAGGAGTGGTTTGGGATTA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810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67203425"/>
                  </a:ext>
                </a:extLst>
              </a:tr>
              <a:tr h="1455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CGAGGAATCGGTCACTTTG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98143266"/>
                  </a:ext>
                </a:extLst>
              </a:tr>
              <a:tr h="145589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slc6a18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GGAGACCAAAGTGGGACAATAA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891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43469880"/>
                  </a:ext>
                </a:extLst>
              </a:tr>
              <a:tr h="1455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GCCAAGCAAGGAGAAGATG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30900309"/>
                  </a:ext>
                </a:extLst>
              </a:tr>
              <a:tr h="145589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slc6a20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CCTTGGCTCTTCTGGTGATAG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796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09261503"/>
                  </a:ext>
                </a:extLst>
              </a:tr>
              <a:tr h="1455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GACCAGAGGGAATGATGGTAAA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88250635"/>
                  </a:ext>
                </a:extLst>
              </a:tr>
              <a:tr h="145589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slc7a2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CGCTGTTTGTCCACCATAGA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874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56675201"/>
                  </a:ext>
                </a:extLst>
              </a:tr>
              <a:tr h="1455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TTGCATCCAGCAGGTAGTAAG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94055039"/>
                  </a:ext>
                </a:extLst>
              </a:tr>
              <a:tr h="145589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slc7a3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TGTGGCCTACTTTGGTGTATC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561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82590454"/>
                  </a:ext>
                </a:extLst>
              </a:tr>
              <a:tr h="1455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GGAGATTGTTCGTCTGGGTAAA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80137833"/>
                  </a:ext>
                </a:extLst>
              </a:tr>
              <a:tr h="145589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slc7a6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GCCTACATACTGGAGTCCTTTG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503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60473962"/>
                  </a:ext>
                </a:extLst>
              </a:tr>
              <a:tr h="1455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CACGTCACAACAGGCATAGA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05411656"/>
                  </a:ext>
                </a:extLst>
              </a:tr>
              <a:tr h="145589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slc7a7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CTTGACCAACGTGGCCTATTA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835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31548156"/>
                  </a:ext>
                </a:extLst>
              </a:tr>
              <a:tr h="1455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GGGATGAAAGCCTAACCTGTAG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56520455"/>
                  </a:ext>
                </a:extLst>
              </a:tr>
              <a:tr h="145589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slc7a8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CATCATCATGGGCTTTGTTCAG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816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82236172"/>
                  </a:ext>
                </a:extLst>
              </a:tr>
              <a:tr h="1455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GGCTTGTTGCTCCAGTAGAT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16411726"/>
                  </a:ext>
                </a:extLst>
              </a:tr>
              <a:tr h="145589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slc7a9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CCCTCTTCCTTTGCGATAAT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921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49480253"/>
                  </a:ext>
                </a:extLst>
              </a:tr>
              <a:tr h="1455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GGAGCGAGAACCAAGTAGATAG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14991487"/>
                  </a:ext>
                </a:extLst>
              </a:tr>
              <a:tr h="145589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slc36a1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GCTCTTCGCCTGATGTTTCT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920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07781220"/>
                  </a:ext>
                </a:extLst>
              </a:tr>
              <a:tr h="1455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CGCTGGCAAATTGAGTGTTATG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95517232"/>
                  </a:ext>
                </a:extLst>
              </a:tr>
              <a:tr h="145589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slc36a4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GACGAAGAGGGTATCTCGTTTAC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618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91897015"/>
                  </a:ext>
                </a:extLst>
              </a:tr>
              <a:tr h="1455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GTGAGGCATGTCCCTCATAAT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31616759"/>
                  </a:ext>
                </a:extLst>
              </a:tr>
              <a:tr h="145589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slc38a2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GCTGGCGATACCATGACTATAA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946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58196892"/>
                  </a:ext>
                </a:extLst>
              </a:tr>
              <a:tr h="1455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TCAGAATTGGCACAGCATAGA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46410991"/>
                  </a:ext>
                </a:extLst>
              </a:tr>
              <a:tr h="145589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slc38a5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GGCCTTCCTTGCCTCATTTA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754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59157918"/>
                  </a:ext>
                </a:extLst>
              </a:tr>
              <a:tr h="1455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CGATCATTGACAGGTGGGTATC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44370773"/>
                  </a:ext>
                </a:extLst>
              </a:tr>
              <a:tr h="145589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slc38a7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CAGTCAAAGGCCACTGGTATAG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521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94558852"/>
                  </a:ext>
                </a:extLst>
              </a:tr>
              <a:tr h="1455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GTGAAGGATTGGGTAGGATGTG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5411990"/>
                  </a:ext>
                </a:extLst>
              </a:tr>
              <a:tr h="145589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slc43a2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TCGCCATGGACAAGTATGG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782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23521784"/>
                  </a:ext>
                </a:extLst>
              </a:tr>
              <a:tr h="1455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CTCCGAAGATTGAGGAGTAGA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77198980"/>
                  </a:ext>
                </a:extLst>
              </a:tr>
              <a:tr h="145589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apoa1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CCTCTGTCCGATGAGATTCAAG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950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93989041"/>
                  </a:ext>
                </a:extLst>
              </a:tr>
              <a:tr h="1455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GTCCTGGTGATCGGCAAATA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6131909"/>
                  </a:ext>
                </a:extLst>
              </a:tr>
              <a:tr h="145589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apob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CACCTCTGCTAAGGGATCTA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905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28140758"/>
                  </a:ext>
                </a:extLst>
              </a:tr>
              <a:tr h="1455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GCTGAGAACTTCCTGCATTTG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00517496"/>
                  </a:ext>
                </a:extLst>
              </a:tr>
              <a:tr h="145589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abca1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ACATCACCACCTCCATCATC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585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78665726"/>
                  </a:ext>
                </a:extLst>
              </a:tr>
              <a:tr h="1455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CTGCTCCACCTCCATCTTTAC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19080710"/>
                  </a:ext>
                </a:extLst>
              </a:tr>
              <a:tr h="145589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mtp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CTGGGTGCTGTTGATCCTAAT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932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36023134"/>
                  </a:ext>
                </a:extLst>
              </a:tr>
              <a:tr h="1455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TCTTGGGCTCCAGTTCTTTC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9401613"/>
                  </a:ext>
                </a:extLst>
              </a:tr>
              <a:tr h="145589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ctsa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CCCAGCTTTAGGCAGTATTC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850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2292451"/>
                  </a:ext>
                </a:extLst>
              </a:tr>
              <a:tr h="1455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GTGGCTCTGTTGTGTCTCTT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89811492"/>
                  </a:ext>
                </a:extLst>
              </a:tr>
              <a:tr h="145589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ctsb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CTCTCAGGACATGGTCAACTTC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570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10769443"/>
                  </a:ext>
                </a:extLst>
              </a:tr>
              <a:tr h="1455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GTGTAACCAGCCTCACATCTC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79607356"/>
                  </a:ext>
                </a:extLst>
              </a:tr>
              <a:tr h="145589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ctsf1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GAGGAGGACAGGTTCCAAATC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771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84750741"/>
                  </a:ext>
                </a:extLst>
              </a:tr>
              <a:tr h="1455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GGAGTTCTTCACGGTCCAATAA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33250961"/>
                  </a:ext>
                </a:extLst>
              </a:tr>
              <a:tr h="145589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ctsf2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CGGTCCCAGTTCAAGGATTT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291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13786335"/>
                  </a:ext>
                </a:extLst>
              </a:tr>
              <a:tr h="1455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CTTGCTGGGTATGGACAGATTAG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03780"/>
                  </a:ext>
                </a:extLst>
              </a:tr>
              <a:tr h="145589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ctsl1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GCTCCACTAACTCTCCTCAAAC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598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55310234"/>
                  </a:ext>
                </a:extLst>
              </a:tr>
              <a:tr h="1455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GGTCCATCAGTCCACCATTAC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93951783"/>
                  </a:ext>
                </a:extLst>
              </a:tr>
              <a:tr h="145589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ctsl2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CCTCCCAATCGAAGCTGATAAC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586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14820333"/>
                  </a:ext>
                </a:extLst>
              </a:tr>
              <a:tr h="1455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GTGGTTCTTGCACCGACTATAC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71536845"/>
                  </a:ext>
                </a:extLst>
              </a:tr>
              <a:tr h="145589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lipa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GGAGGCGTTCTGGACATTTA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799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0454498"/>
                  </a:ext>
                </a:extLst>
              </a:tr>
              <a:tr h="1455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CGCAGCTCACTCATACTTTCT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86373244"/>
                  </a:ext>
                </a:extLst>
              </a:tr>
              <a:tr h="145589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trypsin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AACACCCAGCCTACAACTAC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524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3713552"/>
                  </a:ext>
                </a:extLst>
              </a:tr>
              <a:tr h="1455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GGACACGGAGCTGAGATTTATT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2497011"/>
                  </a:ext>
                </a:extLst>
              </a:tr>
              <a:tr h="145589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bsdl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CACCAGGTAACCAAGGTCTATG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760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93308932"/>
                  </a:ext>
                </a:extLst>
              </a:tr>
              <a:tr h="1455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CCCTGAGTATGTCGAGAATGAAG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37474163"/>
                  </a:ext>
                </a:extLst>
              </a:tr>
              <a:tr h="145589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pla2g1b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AATGCGATCCTTGGTCCTC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436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18701915"/>
                  </a:ext>
                </a:extLst>
              </a:tr>
              <a:tr h="1455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CAACAGTAACGATCCCTGTCAA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1254994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632426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表 5">
            <a:extLst>
              <a:ext uri="{FF2B5EF4-FFF2-40B4-BE49-F238E27FC236}">
                <a16:creationId xmlns:a16="http://schemas.microsoft.com/office/drawing/2014/main" id="{AF65FD37-89AF-4A90-8A66-19DBACDF36D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06344214"/>
              </p:ext>
            </p:extLst>
          </p:nvPr>
        </p:nvGraphicFramePr>
        <p:xfrm>
          <a:off x="938419" y="184737"/>
          <a:ext cx="4911711" cy="9433683"/>
        </p:xfrm>
        <a:graphic>
          <a:graphicData uri="http://schemas.openxmlformats.org/drawingml/2006/table">
            <a:tbl>
              <a:tblPr/>
              <a:tblGrid>
                <a:gridCol w="769140">
                  <a:extLst>
                    <a:ext uri="{9D8B030D-6E8A-4147-A177-3AD203B41FA5}">
                      <a16:colId xmlns:a16="http://schemas.microsoft.com/office/drawing/2014/main" val="3561159446"/>
                    </a:ext>
                  </a:extLst>
                </a:gridCol>
                <a:gridCol w="1106485">
                  <a:extLst>
                    <a:ext uri="{9D8B030D-6E8A-4147-A177-3AD203B41FA5}">
                      <a16:colId xmlns:a16="http://schemas.microsoft.com/office/drawing/2014/main" val="2685972386"/>
                    </a:ext>
                  </a:extLst>
                </a:gridCol>
                <a:gridCol w="2238620">
                  <a:extLst>
                    <a:ext uri="{9D8B030D-6E8A-4147-A177-3AD203B41FA5}">
                      <a16:colId xmlns:a16="http://schemas.microsoft.com/office/drawing/2014/main" val="3983712611"/>
                    </a:ext>
                  </a:extLst>
                </a:gridCol>
                <a:gridCol w="797466">
                  <a:extLst>
                    <a:ext uri="{9D8B030D-6E8A-4147-A177-3AD203B41FA5}">
                      <a16:colId xmlns:a16="http://schemas.microsoft.com/office/drawing/2014/main" val="2733552215"/>
                    </a:ext>
                  </a:extLst>
                </a:gridCol>
              </a:tblGrid>
              <a:tr h="149741">
                <a:tc gridSpan="4"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Primer sets for real-time qPCR assay (5′ to 3′)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384645064"/>
                  </a:ext>
                </a:extLst>
              </a:tr>
              <a:tr h="149741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slc1a6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CGTCGTCACCCATCAATCTTAC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102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  <a:prstDash val="soli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21436281"/>
                  </a:ext>
                </a:extLst>
              </a:tr>
              <a:tr h="14974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CCTCCTCATCAAGCATCAACTC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8710260"/>
                  </a:ext>
                </a:extLst>
              </a:tr>
              <a:tr h="149741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slc3a1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CTTGGAACTCCGACCACTTAC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113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9328332"/>
                  </a:ext>
                </a:extLst>
              </a:tr>
              <a:tr h="14974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TCTCGATTTGCTGTTGGATCA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74544071"/>
                  </a:ext>
                </a:extLst>
              </a:tr>
              <a:tr h="149741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slc3a2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GCTTCATCGCTGGAACAGTA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104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08625968"/>
                  </a:ext>
                </a:extLst>
              </a:tr>
              <a:tr h="14974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TCCTCCAGTCCAATCTCATCT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0908514"/>
                  </a:ext>
                </a:extLst>
              </a:tr>
              <a:tr h="149741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slc6a18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GATGCAGCCACCCAGATATT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97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66135961"/>
                  </a:ext>
                </a:extLst>
              </a:tr>
              <a:tr h="14974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CCACCTCGCAGTTGTTCTT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55684749"/>
                  </a:ext>
                </a:extLst>
              </a:tr>
              <a:tr h="149741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slc6a20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GGCTCTTCTGGTGATAGTTCTG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103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3946943"/>
                  </a:ext>
                </a:extLst>
              </a:tr>
              <a:tr h="14974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TGGCTTGTGTCCTATCATCTTT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5133284"/>
                  </a:ext>
                </a:extLst>
              </a:tr>
              <a:tr h="149741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slc7a2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(same with the cloning primer)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82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4801714"/>
                  </a:ext>
                </a:extLst>
              </a:tr>
              <a:tr h="14974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CCTCACCAGCTAGAACGTAAAC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30282447"/>
                  </a:ext>
                </a:extLst>
              </a:tr>
              <a:tr h="149741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slc7a3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GTGGCCTACTTTGGTGTATCT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107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35826833"/>
                  </a:ext>
                </a:extLst>
              </a:tr>
              <a:tr h="14974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GGTTCCCAGCCAACATACT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61330848"/>
                  </a:ext>
                </a:extLst>
              </a:tr>
              <a:tr h="149741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slc7a6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CTCCGGTTGGGATACTCTTA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100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7987079"/>
                  </a:ext>
                </a:extLst>
              </a:tr>
              <a:tr h="14974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(same with the cloning primer)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16554252"/>
                  </a:ext>
                </a:extLst>
              </a:tr>
              <a:tr h="149741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slc7a7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CCACCTGCCAGAACATAAGA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91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90788542"/>
                  </a:ext>
                </a:extLst>
              </a:tr>
              <a:tr h="14974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CAGGACACAGTAGCAGATCAA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66308945"/>
                  </a:ext>
                </a:extLst>
              </a:tr>
              <a:tr h="149741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slc7a8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GGGAGTGATGTCCTGGATTATG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88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40642527"/>
                  </a:ext>
                </a:extLst>
              </a:tr>
              <a:tr h="14974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CAACCTTGAGGAGGTGAAGAG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29998813"/>
                  </a:ext>
                </a:extLst>
              </a:tr>
              <a:tr h="149741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slc7a9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GTCATCATTGTGGCTGGAATTG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105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10219033"/>
                  </a:ext>
                </a:extLst>
              </a:tr>
              <a:tr h="14974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CGCCAAACCAATAGAACCAAAG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53705155"/>
                  </a:ext>
                </a:extLst>
              </a:tr>
              <a:tr h="149741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slc36a1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CTGGAAATACCTGGCACCTT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121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58381177"/>
                  </a:ext>
                </a:extLst>
              </a:tr>
              <a:tr h="14974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GCCACTGGTGGTAGATTATTG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32211121"/>
                  </a:ext>
                </a:extLst>
              </a:tr>
              <a:tr h="149741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slc36a4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TGCTCAGCTTGCTTCCTTT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102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65672330"/>
                  </a:ext>
                </a:extLst>
              </a:tr>
              <a:tr h="14974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GACTGACAGCCATTGAGAGATT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06176261"/>
                  </a:ext>
                </a:extLst>
              </a:tr>
              <a:tr h="149741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slc38a2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GAGCTACATCAAGCTACCTCTAC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97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25211254"/>
                  </a:ext>
                </a:extLst>
              </a:tr>
              <a:tr h="14974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GGTACCAATGCCCAGTATTT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19247578"/>
                  </a:ext>
                </a:extLst>
              </a:tr>
              <a:tr h="149741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slc38a5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CGGTTGAAAGCTGCCTATTTATT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126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71437896"/>
                  </a:ext>
                </a:extLst>
              </a:tr>
              <a:tr h="14974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CCAAGAGCGTCTTCCATTCT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30302049"/>
                  </a:ext>
                </a:extLst>
              </a:tr>
              <a:tr h="149741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slc38a7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(same with the cloning primer)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123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21176092"/>
                  </a:ext>
                </a:extLst>
              </a:tr>
              <a:tr h="14974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CACTCAGGGTACTGGCATATTT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28447162"/>
                  </a:ext>
                </a:extLst>
              </a:tr>
              <a:tr h="149741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slc43a2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TCTCCTGCTTACTGATTGCTTAC</a:t>
                      </a:r>
                      <a:endParaRPr kumimoji="1" lang="ja-JP" altLang="en-US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118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23022869"/>
                  </a:ext>
                </a:extLst>
              </a:tr>
              <a:tr h="14974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GTCAGTGAGGTGAAGGTCATAC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92554217"/>
                  </a:ext>
                </a:extLst>
              </a:tr>
              <a:tr h="149741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apoA1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GGTTGAAGCTGGAAGAGAAGAT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104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35287171"/>
                  </a:ext>
                </a:extLst>
              </a:tr>
              <a:tr h="14974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CTCAACACTCTGATTGACCCTAC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12861818"/>
                  </a:ext>
                </a:extLst>
              </a:tr>
              <a:tr h="149741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apob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GGGCTTCAGACGATTCAGATT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102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5775205"/>
                  </a:ext>
                </a:extLst>
              </a:tr>
              <a:tr h="14974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AAGTAAGCGGGTAGGTGTTC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86329562"/>
                  </a:ext>
                </a:extLst>
              </a:tr>
              <a:tr h="149741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abca1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CTGGTACATCGAGGCAGTTT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92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52621086"/>
                  </a:ext>
                </a:extLst>
              </a:tr>
              <a:tr h="14974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CCGTGTCTCCACACCAATAG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74561457"/>
                  </a:ext>
                </a:extLst>
              </a:tr>
              <a:tr h="149741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mtp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(same with the cloning primer)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110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32445522"/>
                  </a:ext>
                </a:extLst>
              </a:tr>
              <a:tr h="14974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CCTCCGCGGTATAACTGTATTT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93002311"/>
                  </a:ext>
                </a:extLst>
              </a:tr>
              <a:tr h="149741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ctsa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(same with the cloning primer)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109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4028579"/>
                  </a:ext>
                </a:extLst>
              </a:tr>
              <a:tr h="14974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CAGAACCACAGGATCATTCTCA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96157081"/>
                  </a:ext>
                </a:extLst>
              </a:tr>
              <a:tr h="149741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ctsb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(same with the cloning primer)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85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73369301"/>
                  </a:ext>
                </a:extLst>
              </a:tr>
              <a:tr h="14974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GTAACTGGCCGGAACATTCT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37761398"/>
                  </a:ext>
                </a:extLst>
              </a:tr>
              <a:tr h="149741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ctsf1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CTCAACCCAGTGATCAGTAACA</a:t>
                      </a:r>
                      <a:r>
                        <a:rPr lang="ja-JP" alt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　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103</a:t>
                      </a:r>
                      <a:r>
                        <a:rPr lang="ja-JP" alt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　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22229710"/>
                  </a:ext>
                </a:extLst>
              </a:tr>
              <a:tr h="14974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CCCAATGAGAAGGACAAGACA</a:t>
                      </a:r>
                      <a:r>
                        <a:rPr lang="ja-JP" alt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　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0637502"/>
                  </a:ext>
                </a:extLst>
              </a:tr>
              <a:tr h="149741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ctsf2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GAGAAGAGGTTCCAGATCTTTGT</a:t>
                      </a:r>
                      <a:r>
                        <a:rPr lang="ja-JP" alt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　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142</a:t>
                      </a:r>
                      <a:r>
                        <a:rPr lang="ja-JP" alt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　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38235565"/>
                  </a:ext>
                </a:extLst>
              </a:tr>
              <a:tr h="14974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TTGGGTTGAGGTAGAAGTTAGC</a:t>
                      </a:r>
                      <a:r>
                        <a:rPr lang="ja-JP" alt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　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47091801"/>
                  </a:ext>
                </a:extLst>
              </a:tr>
              <a:tr h="149741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ctsl1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(same with the cloning primer)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82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96851333"/>
                  </a:ext>
                </a:extLst>
              </a:tr>
              <a:tr h="14974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GACTCCAACCAGGCATAAAG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12986932"/>
                  </a:ext>
                </a:extLst>
              </a:tr>
              <a:tr h="149741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ctsl2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CGAAGCGCACGGTATTT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127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9334766"/>
                  </a:ext>
                </a:extLst>
              </a:tr>
              <a:tr h="14974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GTGGTTCTTGCACCGACTAT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70383156"/>
                  </a:ext>
                </a:extLst>
              </a:tr>
              <a:tr h="149741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lipa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GGCCATTCTCAGGGAACAA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95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29051638"/>
                  </a:ext>
                </a:extLst>
              </a:tr>
              <a:tr h="14974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CAGGAGCCAAGGCAATAAA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6266933"/>
                  </a:ext>
                </a:extLst>
              </a:tr>
              <a:tr h="149741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trypsin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GGTCTGCAATTTCGTCTCCT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117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39442606"/>
                  </a:ext>
                </a:extLst>
              </a:tr>
              <a:tr h="14974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(same with the cloning primer)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38478138"/>
                  </a:ext>
                </a:extLst>
              </a:tr>
              <a:tr h="149741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bsdl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50" charset="-128"/>
                      </a:endParaRP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CCTACCCGAGCGATCTGTATAA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101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5446973"/>
                  </a:ext>
                </a:extLst>
              </a:tr>
              <a:tr h="14974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GGCCAGTCTTTGGTGTATTG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9550730"/>
                  </a:ext>
                </a:extLst>
              </a:tr>
              <a:tr h="149741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tpla2g1b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GACAAGTGCTGCCTAAATCA</a:t>
                      </a:r>
                      <a:endParaRPr kumimoji="1" lang="ja-JP" altLang="en-US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117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0605590"/>
                  </a:ext>
                </a:extLst>
              </a:tr>
              <a:tr h="14974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Antisense:</a:t>
                      </a:r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Yu Gothic" panose="020B0400000000000000" pitchFamily="50" charset="-128"/>
                        </a:rPr>
                        <a:t>GTCTTCCCAGAGCAAGAATAGG</a:t>
                      </a:r>
                      <a:endParaRPr kumimoji="1" lang="ja-JP" altLang="en-US" dirty="0"/>
                    </a:p>
                  </a:txBody>
                  <a:tcPr marL="2701" marR="2701" marT="270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EBEBE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5652598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2728022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</TotalTime>
  <Words>583</Words>
  <Application>Microsoft Office PowerPoint</Application>
  <PresentationFormat>A4 Paper (210x297 mm)</PresentationFormat>
  <Paragraphs>37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テーマ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Wataru Takagi</dc:creator>
  <cp:lastModifiedBy>HYD OFF33</cp:lastModifiedBy>
  <cp:revision>12</cp:revision>
  <dcterms:created xsi:type="dcterms:W3CDTF">2021-11-22T08:43:41Z</dcterms:created>
  <dcterms:modified xsi:type="dcterms:W3CDTF">2022-03-08T05:21:03Z</dcterms:modified>
</cp:coreProperties>
</file>